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560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radonzelli:Downloads:17-2-15%20%20u87%20mcf7%20t47d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radonzelli:Downloads:17-2-15%20%20u87%20mcf7%20t47d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radonzelli:Documents:Laboratorio:epilepsy%20mirna:neuro%20oncology:ripsoste:real%20time%20u87mg%202&#176;%20e%203&#176;prep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it-IT" sz="1200"/>
              <a:t>U87MG</a:t>
            </a:r>
          </a:p>
        </c:rich>
      </c:tx>
      <c:layout>
        <c:manualLayout>
          <c:xMode val="edge"/>
          <c:yMode val="edge"/>
          <c:x val="0.306635806380609"/>
          <c:y val="8.921371769052929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4206492666235"/>
          <c:y val="0.2"/>
          <c:w val="0.45313847775191302"/>
          <c:h val="0.366613291254135"/>
        </c:manualLayout>
      </c:layout>
      <c:lineChart>
        <c:grouping val="standard"/>
        <c:varyColors val="0"/>
        <c:ser>
          <c:idx val="0"/>
          <c:order val="0"/>
          <c:tx>
            <c:v>control</c:v>
          </c:tx>
          <c:spPr>
            <a:ln>
              <a:solidFill>
                <a:srgbClr val="000000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oglio1!$I$11:$L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0824829046386233</c:v>
                  </c:pt>
                  <c:pt idx="2">
                    <c:v>8.1649658092772661</c:v>
                  </c:pt>
                  <c:pt idx="3">
                    <c:v>8.9442719099990633</c:v>
                  </c:pt>
                </c:numCache>
              </c:numRef>
            </c:plus>
            <c:minus>
              <c:numRef>
                <c:f>Foglio1!$I$11:$L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0824829046386233</c:v>
                  </c:pt>
                  <c:pt idx="2">
                    <c:v>8.1649658092772661</c:v>
                  </c:pt>
                  <c:pt idx="3">
                    <c:v>8.9442719099990633</c:v>
                  </c:pt>
                </c:numCache>
              </c:numRef>
            </c:minus>
          </c:errBars>
          <c:cat>
            <c:strRef>
              <c:f>Foglio1!$I$52:$I$58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Foglio1!$I$10:$L$10</c:f>
              <c:numCache>
                <c:formatCode>General</c:formatCode>
                <c:ptCount val="4"/>
                <c:pt idx="0">
                  <c:v>20</c:v>
                </c:pt>
                <c:pt idx="1">
                  <c:v>28.333333333333279</c:v>
                </c:pt>
                <c:pt idx="2">
                  <c:v>43.333333333333343</c:v>
                </c:pt>
                <c:pt idx="3">
                  <c:v>46</c:v>
                </c:pt>
              </c:numCache>
            </c:numRef>
          </c:val>
          <c:smooth val="0"/>
        </c:ser>
        <c:ser>
          <c:idx val="1"/>
          <c:order val="1"/>
          <c:tx>
            <c:v>miR-107</c:v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oglio1!$I$22:$L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4772255750516603</c:v>
                  </c:pt>
                  <c:pt idx="2">
                    <c:v>11.69045194450012</c:v>
                  </c:pt>
                  <c:pt idx="3">
                    <c:v>8.1649658092772466</c:v>
                  </c:pt>
                </c:numCache>
              </c:numRef>
            </c:plus>
            <c:minus>
              <c:numRef>
                <c:f>Foglio1!$I$22:$L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4772255750516603</c:v>
                  </c:pt>
                  <c:pt idx="2">
                    <c:v>11.69045194450012</c:v>
                  </c:pt>
                  <c:pt idx="3">
                    <c:v>8.1649658092772466</c:v>
                  </c:pt>
                </c:numCache>
              </c:numRef>
            </c:minus>
          </c:errBars>
          <c:cat>
            <c:strRef>
              <c:f>Foglio1!$I$52:$I$58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Foglio1!$I$21:$L$21</c:f>
              <c:numCache>
                <c:formatCode>General</c:formatCode>
                <c:ptCount val="4"/>
                <c:pt idx="0">
                  <c:v>20</c:v>
                </c:pt>
                <c:pt idx="1">
                  <c:v>15</c:v>
                </c:pt>
                <c:pt idx="2">
                  <c:v>28.333333333333279</c:v>
                </c:pt>
                <c:pt idx="3">
                  <c:v>53.33333333333334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4188544"/>
        <c:axId val="104190336"/>
      </c:lineChart>
      <c:catAx>
        <c:axId val="104188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4190336"/>
        <c:crosses val="autoZero"/>
        <c:auto val="1"/>
        <c:lblAlgn val="ctr"/>
        <c:lblOffset val="100"/>
        <c:noMultiLvlLbl val="0"/>
      </c:catAx>
      <c:valAx>
        <c:axId val="10419033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n°cells 10^3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041885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05446395816519"/>
          <c:y val="0.65230312255406298"/>
          <c:w val="0.21678835135369501"/>
          <c:h val="0.177398131651053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it-IT" sz="1200"/>
              <a:t>U87MG</a:t>
            </a:r>
          </a:p>
        </c:rich>
      </c:tx>
      <c:layout>
        <c:manualLayout>
          <c:xMode val="edge"/>
          <c:yMode val="edge"/>
          <c:x val="0.34954602062483803"/>
          <c:y val="6.481481481481479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8772669850286298"/>
          <c:y val="0.187962962962963"/>
          <c:w val="0.31037889851540601"/>
          <c:h val="0.421871172353456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17-2-15  u87 mcf7 t47d.xls]Foglio1'!$C$26,'[17-2-15  u87 mcf7 t47d.xls]Foglio1'!$C$29</c:f>
                <c:numCache>
                  <c:formatCode>General</c:formatCode>
                  <c:ptCount val="2"/>
                  <c:pt idx="0">
                    <c:v>57353.217888800224</c:v>
                  </c:pt>
                  <c:pt idx="1">
                    <c:v>263944.500749114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33:$B$38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'[17-2-15  u87 mcf7 t47d.xls]Foglio1'!$B$26,'[17-2-15  u87 mcf7 t47d.xls]Foglio1'!$B$29</c:f>
              <c:numCache>
                <c:formatCode>General</c:formatCode>
                <c:ptCount val="2"/>
                <c:pt idx="0">
                  <c:v>2515501</c:v>
                </c:pt>
                <c:pt idx="1">
                  <c:v>3072024</c:v>
                </c:pt>
              </c:numCache>
            </c:numRef>
          </c:val>
        </c:ser>
        <c:ser>
          <c:idx val="1"/>
          <c:order val="1"/>
          <c:tx>
            <c:v>mir-107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17-2-15  u87 mcf7 t47d.xls]Foglio1'!$C$27,'[17-2-15  u87 mcf7 t47d.xls]Foglio1'!$C$30</c:f>
                <c:numCache>
                  <c:formatCode>General</c:formatCode>
                  <c:ptCount val="2"/>
                  <c:pt idx="0">
                    <c:v>194873.09764382761</c:v>
                  </c:pt>
                  <c:pt idx="1">
                    <c:v>368263.635191827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33:$B$38</c:f>
              <c:strCache>
                <c:ptCount val="2"/>
                <c:pt idx="0">
                  <c:v>48h</c:v>
                </c:pt>
                <c:pt idx="1">
                  <c:v>72h</c:v>
                </c:pt>
              </c:strCache>
            </c:strRef>
          </c:cat>
          <c:val>
            <c:numRef>
              <c:f>'[17-2-15  u87 mcf7 t47d.xls]Foglio1'!$B$27,'[17-2-15  u87 mcf7 t47d.xls]Foglio1'!$B$30</c:f>
              <c:numCache>
                <c:formatCode>General</c:formatCode>
                <c:ptCount val="2"/>
                <c:pt idx="0">
                  <c:v>2710025</c:v>
                </c:pt>
                <c:pt idx="1">
                  <c:v>40208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491264"/>
        <c:axId val="104493056"/>
      </c:barChart>
      <c:catAx>
        <c:axId val="104491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4493056"/>
        <c:crosses val="autoZero"/>
        <c:auto val="1"/>
        <c:lblAlgn val="ctr"/>
        <c:lblOffset val="100"/>
        <c:noMultiLvlLbl val="0"/>
      </c:catAx>
      <c:valAx>
        <c:axId val="10449305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ATPlite counts/s</a:t>
                </a:r>
              </a:p>
            </c:rich>
          </c:tx>
          <c:layout>
            <c:manualLayout>
              <c:xMode val="edge"/>
              <c:yMode val="edge"/>
              <c:x val="0"/>
              <c:y val="0.2275692621755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04491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462679078601902"/>
          <c:y val="0.26489391951006103"/>
          <c:w val="0.27214858484226701"/>
          <c:h val="0.167434383202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/>
              <a:t>miR-195-5p</a:t>
            </a:r>
          </a:p>
        </c:rich>
      </c:tx>
      <c:layout>
        <c:manualLayout>
          <c:xMode val="edge"/>
          <c:yMode val="edge"/>
          <c:x val="0.26240288839014297"/>
          <c:y val="5.223880597014920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259534765018101"/>
          <c:y val="0.15314901868609701"/>
          <c:w val="0.44508643402415499"/>
          <c:h val="0.695010372954878"/>
        </c:manualLayout>
      </c:layout>
      <c:barChart>
        <c:barDir val="col"/>
        <c:grouping val="clustered"/>
        <c:varyColors val="0"/>
        <c:ser>
          <c:idx val="0"/>
          <c:order val="0"/>
          <c:tx>
            <c:v>inh ctrl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I$31,Sheet1!$I$33,Sheet1!$I$35)</c:f>
                <c:numCache>
                  <c:formatCode>General</c:formatCode>
                  <c:ptCount val="3"/>
                  <c:pt idx="0">
                    <c:v>5.1464397070073199E-2</c:v>
                  </c:pt>
                  <c:pt idx="1">
                    <c:v>6.8658628270411901E-2</c:v>
                  </c:pt>
                  <c:pt idx="2">
                    <c:v>0.231181451549377</c:v>
                  </c:pt>
                </c:numCache>
              </c:numRef>
            </c:plus>
          </c:errBars>
          <c:cat>
            <c:strRef>
              <c:f>Sheet1!$G$46:$G$48</c:f>
              <c:strCache>
                <c:ptCount val="3"/>
                <c:pt idx="0">
                  <c:v>NT</c:v>
                </c:pt>
                <c:pt idx="1">
                  <c:v>BRV</c:v>
                </c:pt>
                <c:pt idx="2">
                  <c:v>LCM</c:v>
                </c:pt>
              </c:strCache>
            </c:strRef>
          </c:cat>
          <c:val>
            <c:numRef>
              <c:f>(Sheet1!$H$31,Sheet1!$H$33,Sheet1!$H$35)</c:f>
              <c:numCache>
                <c:formatCode>0.00</c:formatCode>
                <c:ptCount val="3"/>
                <c:pt idx="0">
                  <c:v>1.000661926967791</c:v>
                </c:pt>
                <c:pt idx="1">
                  <c:v>1.248640553147031</c:v>
                </c:pt>
                <c:pt idx="2">
                  <c:v>1.5534335807316131</c:v>
                </c:pt>
              </c:numCache>
            </c:numRef>
          </c:val>
        </c:ser>
        <c:ser>
          <c:idx val="1"/>
          <c:order val="1"/>
          <c:tx>
            <c:v>inh miR-195-5p</c:v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I$37,Sheet1!$I$39,Sheet1!$I$41)</c:f>
                <c:numCache>
                  <c:formatCode>General</c:formatCode>
                  <c:ptCount val="3"/>
                  <c:pt idx="0">
                    <c:v>2.7070244122676501E-2</c:v>
                  </c:pt>
                  <c:pt idx="1">
                    <c:v>2.43894504586246E-2</c:v>
                  </c:pt>
                  <c:pt idx="2">
                    <c:v>1.4286409262827199E-2</c:v>
                  </c:pt>
                </c:numCache>
              </c:numRef>
            </c:plus>
          </c:errBars>
          <c:cat>
            <c:strRef>
              <c:f>Sheet1!$G$46:$G$48</c:f>
              <c:strCache>
                <c:ptCount val="3"/>
                <c:pt idx="0">
                  <c:v>NT</c:v>
                </c:pt>
                <c:pt idx="1">
                  <c:v>BRV</c:v>
                </c:pt>
                <c:pt idx="2">
                  <c:v>LCM</c:v>
                </c:pt>
              </c:strCache>
            </c:strRef>
          </c:cat>
          <c:val>
            <c:numRef>
              <c:f>(Sheet1!$H$37,Sheet1!$H$39,Sheet1!$H$41)</c:f>
              <c:numCache>
                <c:formatCode>0.00</c:formatCode>
                <c:ptCount val="3"/>
                <c:pt idx="0">
                  <c:v>0.44836176674573203</c:v>
                </c:pt>
                <c:pt idx="1">
                  <c:v>0.45088142659894198</c:v>
                </c:pt>
                <c:pt idx="2">
                  <c:v>0.419043865788536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519552"/>
        <c:axId val="104521088"/>
      </c:barChart>
      <c:catAx>
        <c:axId val="104519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4521088"/>
        <c:crosses val="autoZero"/>
        <c:auto val="1"/>
        <c:lblAlgn val="ctr"/>
        <c:lblOffset val="100"/>
        <c:noMultiLvlLbl val="0"/>
      </c:catAx>
      <c:valAx>
        <c:axId val="1045210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miR-195-5p/rnu48</a:t>
                </a:r>
              </a:p>
            </c:rich>
          </c:tx>
          <c:layout>
            <c:manualLayout>
              <c:xMode val="edge"/>
              <c:yMode val="edge"/>
              <c:x val="0"/>
              <c:y val="0.1541773416382649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104519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7565585522019502"/>
          <c:y val="0.22102303443412899"/>
          <c:w val="0.419577700547203"/>
          <c:h val="0.2997449759078619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13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8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94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37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47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28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23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32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22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8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80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60918-29F5-2247-9FE9-E70C5C7AC4DE}" type="datetimeFigureOut">
              <a:rPr lang="en-US" smtClean="0"/>
              <a:t>5/3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C6B21-0925-F040-8363-486999D651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5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jpeg"/><Relationship Id="rId5" Type="http://schemas.openxmlformats.org/officeDocument/2006/relationships/image" Target="../media/image1.jpe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17395" y="382364"/>
            <a:ext cx="6678705" cy="3041707"/>
            <a:chOff x="229920" y="5976978"/>
            <a:chExt cx="6678705" cy="3041707"/>
          </a:xfrm>
        </p:grpSpPr>
        <p:grpSp>
          <p:nvGrpSpPr>
            <p:cNvPr id="2" name="Group 1"/>
            <p:cNvGrpSpPr/>
            <p:nvPr/>
          </p:nvGrpSpPr>
          <p:grpSpPr>
            <a:xfrm>
              <a:off x="229920" y="5976978"/>
              <a:ext cx="3782108" cy="2816640"/>
              <a:chOff x="3801694" y="1961405"/>
              <a:chExt cx="3782108" cy="2816640"/>
            </a:xfrm>
          </p:grpSpPr>
          <p:graphicFrame>
            <p:nvGraphicFramePr>
              <p:cNvPr id="3" name="Grafico 45"/>
              <p:cNvGraphicFramePr/>
              <p:nvPr>
                <p:extLst>
                  <p:ext uri="{D42A27DB-BD31-4B8C-83A1-F6EECF244321}">
                    <p14:modId xmlns:p14="http://schemas.microsoft.com/office/powerpoint/2010/main" val="3589565372"/>
                  </p:ext>
                </p:extLst>
              </p:nvPr>
            </p:nvGraphicFramePr>
            <p:xfrm>
              <a:off x="3835727" y="2073304"/>
              <a:ext cx="3748075" cy="27047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CasellaDiTesto 47"/>
              <p:cNvSpPr txBox="1"/>
              <p:nvPr/>
            </p:nvSpPr>
            <p:spPr>
              <a:xfrm>
                <a:off x="3801694" y="1961405"/>
                <a:ext cx="1854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a</a:t>
                </a:r>
                <a:endParaRPr lang="en-US" sz="1200" b="1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3483573" y="5976978"/>
              <a:ext cx="3425052" cy="3041707"/>
              <a:chOff x="7543009" y="3726860"/>
              <a:chExt cx="3425052" cy="3041707"/>
            </a:xfrm>
          </p:grpSpPr>
          <p:graphicFrame>
            <p:nvGraphicFramePr>
              <p:cNvPr id="13" name="Grafico 46"/>
              <p:cNvGraphicFramePr/>
              <p:nvPr>
                <p:extLst>
                  <p:ext uri="{D42A27DB-BD31-4B8C-83A1-F6EECF244321}">
                    <p14:modId xmlns:p14="http://schemas.microsoft.com/office/powerpoint/2010/main" val="3470673771"/>
                  </p:ext>
                </p:extLst>
              </p:nvPr>
            </p:nvGraphicFramePr>
            <p:xfrm>
              <a:off x="8177736" y="4025367"/>
              <a:ext cx="2790325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4" name="CasellaDiTesto 47"/>
              <p:cNvSpPr txBox="1"/>
              <p:nvPr/>
            </p:nvSpPr>
            <p:spPr>
              <a:xfrm>
                <a:off x="7543009" y="3726860"/>
                <a:ext cx="1854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b</a:t>
                </a:r>
                <a:endParaRPr lang="en-US" sz="1200" b="1" dirty="0"/>
              </a:p>
            </p:txBody>
          </p:sp>
        </p:grpSp>
      </p:grpSp>
      <p:grpSp>
        <p:nvGrpSpPr>
          <p:cNvPr id="6" name="Group 5"/>
          <p:cNvGrpSpPr/>
          <p:nvPr/>
        </p:nvGrpSpPr>
        <p:grpSpPr>
          <a:xfrm>
            <a:off x="251428" y="5286080"/>
            <a:ext cx="6413920" cy="2808826"/>
            <a:chOff x="251428" y="2707980"/>
            <a:chExt cx="6413920" cy="2808826"/>
          </a:xfrm>
        </p:grpSpPr>
        <p:grpSp>
          <p:nvGrpSpPr>
            <p:cNvPr id="8" name="Group 7"/>
            <p:cNvGrpSpPr/>
            <p:nvPr/>
          </p:nvGrpSpPr>
          <p:grpSpPr>
            <a:xfrm>
              <a:off x="3471048" y="2707980"/>
              <a:ext cx="3194300" cy="2207406"/>
              <a:chOff x="7003853" y="-24398"/>
              <a:chExt cx="3194300" cy="2207406"/>
            </a:xfrm>
          </p:grpSpPr>
          <p:graphicFrame>
            <p:nvGraphicFramePr>
              <p:cNvPr id="9" name="Chart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30038348"/>
                  </p:ext>
                </p:extLst>
              </p:nvPr>
            </p:nvGraphicFramePr>
            <p:xfrm>
              <a:off x="7533693" y="481208"/>
              <a:ext cx="2664460" cy="1701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" name="CasellaDiTesto 44"/>
              <p:cNvSpPr txBox="1"/>
              <p:nvPr/>
            </p:nvSpPr>
            <p:spPr>
              <a:xfrm>
                <a:off x="7003853" y="-24398"/>
                <a:ext cx="1854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e</a:t>
                </a:r>
                <a:endParaRPr lang="en-US" sz="12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247896" y="202764"/>
                <a:ext cx="7488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U87MG</a:t>
                </a:r>
                <a:endParaRPr lang="en-US" sz="1200" b="1" dirty="0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251428" y="2731984"/>
              <a:ext cx="2928562" cy="2784822"/>
              <a:chOff x="7828706" y="6511383"/>
              <a:chExt cx="2928562" cy="2784822"/>
            </a:xfrm>
          </p:grpSpPr>
          <p:pic>
            <p:nvPicPr>
              <p:cNvPr id="16" name="Immagine 30" descr="IMG_3279.JPG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439437" y="8146225"/>
                <a:ext cx="1500261" cy="1111138"/>
              </a:xfrm>
              <a:prstGeom prst="rect">
                <a:avLst/>
              </a:prstGeom>
            </p:spPr>
          </p:pic>
          <p:pic>
            <p:nvPicPr>
              <p:cNvPr id="17" name="Immagine 31" descr="IMG_3276.JPG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439438" y="7004427"/>
                <a:ext cx="1500260" cy="1111138"/>
              </a:xfrm>
              <a:prstGeom prst="rect">
                <a:avLst/>
              </a:prstGeom>
            </p:spPr>
          </p:pic>
          <p:sp>
            <p:nvSpPr>
              <p:cNvPr id="18" name="CasellaDiTesto 32"/>
              <p:cNvSpPr txBox="1"/>
              <p:nvPr/>
            </p:nvSpPr>
            <p:spPr>
              <a:xfrm>
                <a:off x="7828706" y="6511383"/>
                <a:ext cx="1854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d</a:t>
                </a:r>
                <a:endParaRPr lang="en-US" sz="1200" b="1" dirty="0"/>
              </a:p>
            </p:txBody>
          </p:sp>
          <p:sp>
            <p:nvSpPr>
              <p:cNvPr id="19" name="CasellaDiTesto 33"/>
              <p:cNvSpPr txBox="1"/>
              <p:nvPr/>
            </p:nvSpPr>
            <p:spPr>
              <a:xfrm>
                <a:off x="8411655" y="7852810"/>
                <a:ext cx="23416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ontrol</a:t>
                </a:r>
              </a:p>
            </p:txBody>
          </p:sp>
          <p:sp>
            <p:nvSpPr>
              <p:cNvPr id="20" name="CasellaDiTesto 34"/>
              <p:cNvSpPr txBox="1"/>
              <p:nvPr/>
            </p:nvSpPr>
            <p:spPr>
              <a:xfrm>
                <a:off x="8415611" y="8993918"/>
                <a:ext cx="23416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solidFill>
                      <a:schemeClr val="bg1"/>
                    </a:solidFill>
                  </a:rPr>
                  <a:t>miR-195-5p</a:t>
                </a:r>
              </a:p>
            </p:txBody>
          </p:sp>
          <p:sp>
            <p:nvSpPr>
              <p:cNvPr id="21" name="CasellaDiTesto 35"/>
              <p:cNvSpPr txBox="1"/>
              <p:nvPr/>
            </p:nvSpPr>
            <p:spPr>
              <a:xfrm>
                <a:off x="8865923" y="6677767"/>
                <a:ext cx="9028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U87MG</a:t>
                </a:r>
              </a:p>
            </p:txBody>
          </p:sp>
          <p:sp>
            <p:nvSpPr>
              <p:cNvPr id="22" name="Rettangolo 36"/>
              <p:cNvSpPr/>
              <p:nvPr/>
            </p:nvSpPr>
            <p:spPr>
              <a:xfrm>
                <a:off x="8385306" y="6970559"/>
                <a:ext cx="1630592" cy="232564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3" name="CasellaDiTesto 9"/>
          <p:cNvSpPr txBox="1"/>
          <p:nvPr/>
        </p:nvSpPr>
        <p:spPr>
          <a:xfrm>
            <a:off x="-23905" y="-64964"/>
            <a:ext cx="1854200" cy="283941"/>
          </a:xfrm>
          <a:prstGeom prst="rect">
            <a:avLst/>
          </a:prstGeom>
          <a:noFill/>
        </p:spPr>
        <p:txBody>
          <a:bodyPr wrap="square" lIns="91428" tIns="45714" rIns="91428" bIns="45714" rtlCol="0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</a:rPr>
              <a:t>Figure S7</a:t>
            </a:r>
            <a:endParaRPr lang="en-US" sz="1200" b="1" dirty="0">
              <a:solidFill>
                <a:srgbClr val="000000"/>
              </a:solidFill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98402" y="3013815"/>
            <a:ext cx="7267765" cy="2246063"/>
            <a:chOff x="217395" y="166162"/>
            <a:chExt cx="7267765" cy="2246063"/>
          </a:xfrm>
        </p:grpSpPr>
        <p:pic>
          <p:nvPicPr>
            <p:cNvPr id="27" name="Picture 8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17395" y="564941"/>
              <a:ext cx="3331470" cy="18472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" name="Picture 7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3393145" y="564941"/>
              <a:ext cx="3312455" cy="18367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" name="CasellaDiTesto 20"/>
            <p:cNvSpPr txBox="1"/>
            <p:nvPr/>
          </p:nvSpPr>
          <p:spPr>
            <a:xfrm>
              <a:off x="217395" y="166162"/>
              <a:ext cx="1854200" cy="276999"/>
            </a:xfrm>
            <a:prstGeom prst="rect">
              <a:avLst/>
            </a:prstGeom>
            <a:noFill/>
          </p:spPr>
          <p:txBody>
            <a:bodyPr wrap="square" lIns="83933" tIns="41966" rIns="83933" bIns="41966" rtlCol="0">
              <a:spAutoFit/>
            </a:bodyPr>
            <a:lstStyle/>
            <a:p>
              <a:r>
                <a:rPr lang="en-US" sz="1200" b="1" dirty="0" smtClean="0"/>
                <a:t>c</a:t>
              </a:r>
              <a:endParaRPr lang="en-US" sz="1200" b="1" dirty="0"/>
            </a:p>
          </p:txBody>
        </p:sp>
        <p:sp>
          <p:nvSpPr>
            <p:cNvPr id="31" name="CasellaDiTesto 23"/>
            <p:cNvSpPr txBox="1"/>
            <p:nvPr/>
          </p:nvSpPr>
          <p:spPr>
            <a:xfrm>
              <a:off x="3179990" y="287942"/>
              <a:ext cx="902849" cy="276999"/>
            </a:xfrm>
            <a:prstGeom prst="rect">
              <a:avLst/>
            </a:prstGeom>
            <a:noFill/>
          </p:spPr>
          <p:txBody>
            <a:bodyPr wrap="square" lIns="83933" tIns="41966" rIns="83933" bIns="41966" rtlCol="0">
              <a:spAutoFit/>
            </a:bodyPr>
            <a:lstStyle/>
            <a:p>
              <a:r>
                <a:rPr lang="en-US" sz="1200" b="1" dirty="0"/>
                <a:t>U87MG</a:t>
              </a:r>
            </a:p>
          </p:txBody>
        </p:sp>
        <p:sp>
          <p:nvSpPr>
            <p:cNvPr id="32" name="CasellaDiTesto 24"/>
            <p:cNvSpPr txBox="1"/>
            <p:nvPr/>
          </p:nvSpPr>
          <p:spPr>
            <a:xfrm>
              <a:off x="2798281" y="628650"/>
              <a:ext cx="1824786" cy="276999"/>
            </a:xfrm>
            <a:prstGeom prst="rect">
              <a:avLst/>
            </a:prstGeom>
            <a:noFill/>
          </p:spPr>
          <p:txBody>
            <a:bodyPr wrap="square" lIns="83933" tIns="41966" rIns="83933" bIns="41966" rtlCol="0">
              <a:spAutoFit/>
            </a:bodyPr>
            <a:lstStyle/>
            <a:p>
              <a:r>
                <a:rPr lang="en-US" sz="1200" dirty="0"/>
                <a:t>control</a:t>
              </a:r>
            </a:p>
          </p:txBody>
        </p:sp>
        <p:sp>
          <p:nvSpPr>
            <p:cNvPr id="33" name="CasellaDiTesto 25"/>
            <p:cNvSpPr txBox="1"/>
            <p:nvPr/>
          </p:nvSpPr>
          <p:spPr>
            <a:xfrm>
              <a:off x="5660374" y="628650"/>
              <a:ext cx="1824786" cy="276999"/>
            </a:xfrm>
            <a:prstGeom prst="rect">
              <a:avLst/>
            </a:prstGeom>
            <a:noFill/>
          </p:spPr>
          <p:txBody>
            <a:bodyPr wrap="square" lIns="83933" tIns="41966" rIns="83933" bIns="41966" rtlCol="0">
              <a:spAutoFit/>
            </a:bodyPr>
            <a:lstStyle/>
            <a:p>
              <a:r>
                <a:rPr lang="en-US" sz="1200"/>
                <a:t>miR-195-5p</a:t>
              </a:r>
            </a:p>
          </p:txBody>
        </p:sp>
        <p:pic>
          <p:nvPicPr>
            <p:cNvPr id="35" name="Picture 8"/>
            <p:cNvPicPr>
              <a:picLocks noChangeAspect="1" noChangeArrowheads="1"/>
            </p:cNvPicPr>
            <p:nvPr/>
          </p:nvPicPr>
          <p:blipFill rotWithShape="1">
            <a:blip r:embed="rId7"/>
            <a:srcRect l="42939" t="10668" r="41673" b="64250"/>
            <a:stretch/>
          </p:blipFill>
          <p:spPr bwMode="auto">
            <a:xfrm>
              <a:off x="1529185" y="711200"/>
              <a:ext cx="733555" cy="6630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6" name="Picture 7"/>
            <p:cNvPicPr>
              <a:picLocks noChangeAspect="1" noChangeArrowheads="1"/>
            </p:cNvPicPr>
            <p:nvPr/>
          </p:nvPicPr>
          <p:blipFill rotWithShape="1">
            <a:blip r:embed="rId8"/>
            <a:srcRect l="47474" t="11766" r="40449" b="64236"/>
            <a:stretch/>
          </p:blipFill>
          <p:spPr bwMode="auto">
            <a:xfrm>
              <a:off x="4871999" y="711200"/>
              <a:ext cx="554175" cy="6105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3229848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f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donzelli</dc:creator>
  <cp:lastModifiedBy>Balindan, Danica Joy</cp:lastModifiedBy>
  <cp:revision>11</cp:revision>
  <dcterms:created xsi:type="dcterms:W3CDTF">2017-05-19T15:04:48Z</dcterms:created>
  <dcterms:modified xsi:type="dcterms:W3CDTF">2017-05-31T01:11:21Z</dcterms:modified>
</cp:coreProperties>
</file>